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300" d="100"/>
          <a:sy n="300" d="100"/>
        </p:scale>
        <p:origin x="-288" y="-8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A624C-5720-488D-BE32-4A8AC7EE8137}" type="datetimeFigureOut">
              <a:rPr lang="en-US" smtClean="0"/>
              <a:t>12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7EA1A-F3E4-48FC-94CD-CE8EA0C807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40870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A624C-5720-488D-BE32-4A8AC7EE8137}" type="datetimeFigureOut">
              <a:rPr lang="en-US" smtClean="0"/>
              <a:t>12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7EA1A-F3E4-48FC-94CD-CE8EA0C807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8622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A624C-5720-488D-BE32-4A8AC7EE8137}" type="datetimeFigureOut">
              <a:rPr lang="en-US" smtClean="0"/>
              <a:t>12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7EA1A-F3E4-48FC-94CD-CE8EA0C807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643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A624C-5720-488D-BE32-4A8AC7EE8137}" type="datetimeFigureOut">
              <a:rPr lang="en-US" smtClean="0"/>
              <a:t>12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7EA1A-F3E4-48FC-94CD-CE8EA0C807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11631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A624C-5720-488D-BE32-4A8AC7EE8137}" type="datetimeFigureOut">
              <a:rPr lang="en-US" smtClean="0"/>
              <a:t>12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7EA1A-F3E4-48FC-94CD-CE8EA0C807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64956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A624C-5720-488D-BE32-4A8AC7EE8137}" type="datetimeFigureOut">
              <a:rPr lang="en-US" smtClean="0"/>
              <a:t>12/16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7EA1A-F3E4-48FC-94CD-CE8EA0C807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7334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A624C-5720-488D-BE32-4A8AC7EE8137}" type="datetimeFigureOut">
              <a:rPr lang="en-US" smtClean="0"/>
              <a:t>12/16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7EA1A-F3E4-48FC-94CD-CE8EA0C807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760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A624C-5720-488D-BE32-4A8AC7EE8137}" type="datetimeFigureOut">
              <a:rPr lang="en-US" smtClean="0"/>
              <a:t>12/16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7EA1A-F3E4-48FC-94CD-CE8EA0C807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2857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A624C-5720-488D-BE32-4A8AC7EE8137}" type="datetimeFigureOut">
              <a:rPr lang="en-US" smtClean="0"/>
              <a:t>12/16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7EA1A-F3E4-48FC-94CD-CE8EA0C807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221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A624C-5720-488D-BE32-4A8AC7EE8137}" type="datetimeFigureOut">
              <a:rPr lang="en-US" smtClean="0"/>
              <a:t>12/16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7EA1A-F3E4-48FC-94CD-CE8EA0C807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9314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A624C-5720-488D-BE32-4A8AC7EE8137}" type="datetimeFigureOut">
              <a:rPr lang="en-US" smtClean="0"/>
              <a:t>12/16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7EA1A-F3E4-48FC-94CD-CE8EA0C807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24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0A624C-5720-488D-BE32-4A8AC7EE8137}" type="datetimeFigureOut">
              <a:rPr lang="en-US" smtClean="0"/>
              <a:t>12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87EA1A-F3E4-48FC-94CD-CE8EA0C807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3776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46781" y="838200"/>
            <a:ext cx="6532558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ax3-Foxo1 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tttacttccaaggAGAAGGTAGCCAGTCACTCTGGTGACCTGACTTGTTCCCTCATGGAGCGCCTGTCTTAAACACGGCCCTAATGGCT</a:t>
            </a:r>
          </a:p>
          <a:p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RH3002     </a:t>
            </a:r>
            <a:r>
              <a:rPr lang="en-US" sz="800" dirty="0" err="1" smtClean="0">
                <a:latin typeface="Courier New" panose="02070309020205020404" pitchFamily="49" charset="0"/>
                <a:cs typeface="Courier New" panose="02070309020205020404" pitchFamily="49" charset="0"/>
              </a:rPr>
              <a:t>ttgtttacttccaag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-------------TCACTCTGGTGACCTGACTTGTTCCCTCATGGAGCGCCTGTCTTAAACACGGCCCTAATGGCT</a:t>
            </a:r>
          </a:p>
          <a:p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RH3008     </a:t>
            </a:r>
            <a:r>
              <a:rPr lang="en-US" sz="800" dirty="0" err="1" smtClean="0">
                <a:latin typeface="Courier New" panose="02070309020205020404" pitchFamily="49" charset="0"/>
                <a:cs typeface="Courier New" panose="02070309020205020404" pitchFamily="49" charset="0"/>
              </a:rPr>
              <a:t>ttgtttacttcc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AAACACGGCCCTAATGGCT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RH3006     </a:t>
            </a:r>
            <a:r>
              <a:rPr lang="en-US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ttgtttacttcca</a:t>
            </a:r>
            <a:r>
              <a:rPr lang="en-US" sz="800" dirty="0" err="1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ct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TTGTTCCCTCATGGAGCGCCTGTCTTAAACACGGCCCTAATGGCT</a:t>
            </a:r>
          </a:p>
          <a:p>
            <a:endParaRPr lang="en-US" sz="8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6" name="Straight Connector 5"/>
          <p:cNvCxnSpPr/>
          <p:nvPr/>
        </p:nvCxnSpPr>
        <p:spPr>
          <a:xfrm>
            <a:off x="1981200" y="762000"/>
            <a:ext cx="0" cy="841248"/>
          </a:xfrm>
          <a:prstGeom prst="line">
            <a:avLst/>
          </a:prstGeom>
          <a:ln w="9525"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525510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116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gutin</dc:creator>
  <cp:lastModifiedBy>SJCRH</cp:lastModifiedBy>
  <cp:revision>7</cp:revision>
  <dcterms:created xsi:type="dcterms:W3CDTF">2014-12-05T23:02:41Z</dcterms:created>
  <dcterms:modified xsi:type="dcterms:W3CDTF">2014-12-16T21:32:58Z</dcterms:modified>
</cp:coreProperties>
</file>